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 id="265"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0" d="100"/>
          <a:sy n="80" d="100"/>
        </p:scale>
        <p:origin x="222"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B7E547F-8DCA-404E-A019-47DEA85E835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C32F4669-0A54-4C7C-93EF-0F83D5EF50E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8334689F-304E-4C4B-89CD-92A8DCF6E21F}"/>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5830E575-DF59-47CA-82D2-3E88B23734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3211E2F-16EA-438E-9900-45437FC96F19}"/>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40777583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2BD29F7-FFFB-4985-8BA3-62FDCF58E05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21419274-88F6-4C18-B9FE-F9D28AB60D77}"/>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D1A07A7B-8FAD-47D5-A444-D19ED37F8BDD}"/>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B7089C14-67D1-408B-A774-C1C0E2A0935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6159888-DDE2-4A13-874E-CAC958C2A106}"/>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1484791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82B699AA-D140-479D-9433-6DE3C94C6BC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45585276-3DD9-42F4-B1FE-9DC446664113}"/>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0D0B7921-EB4B-48FA-B2EE-68C4CFD22FD7}"/>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21B854FC-09B8-4706-84FE-6984C46984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304ACD2-4BCF-44EB-B2A7-53E35ADFB5F0}"/>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27499309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2D5A6214-276A-42B4-A537-74BCC663DF0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E4DC4306-5155-4D1B-9BCD-0BF30B9CD87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A871D75F-771E-4EC7-A13F-3DEAA3B61BBA}"/>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F9DC775B-2B56-4887-9BAA-E6097EFBD9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C6C81D77-3978-4BE4-891F-3B470D252112}"/>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18679333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C44FEF2-518A-4E9F-B410-F7BB400DD76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2193DEBF-B3DA-43AA-8F73-FE5A44CAFA4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A7C129C6-BAE5-4FCB-BF92-24230ED5A100}"/>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559CD7E7-2AF5-4002-A338-7B1C738BF2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A5C1EA3-B4C3-4167-8673-39B0DE04BF4F}"/>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26663426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438EC57-39DF-4413-898A-7287979E8E6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3AB05083-9CA4-4FE8-89CB-EFF90B9725B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C63BD511-A9C6-4238-A231-4737DDA4CBA5}"/>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EC6D7BD6-02F7-4A41-9D57-7B2CB838FF57}"/>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6" name="Footer Placeholder 5">
            <a:extLst>
              <a:ext uri="{FF2B5EF4-FFF2-40B4-BE49-F238E27FC236}">
                <a16:creationId xmlns:a16="http://schemas.microsoft.com/office/drawing/2014/main" xmlns="" id="{4682720B-A4B0-4532-B922-E14627AD5A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7B2D8B1C-27FD-4FC6-BCBD-D93DE12569FF}"/>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16323080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952CD40-5965-40B4-86DD-D572C7048BF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E9EDDABD-1B89-4106-BD51-436E37FA548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1E1D5797-8E52-4924-8D7C-3D80E66E98F7}"/>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55721E9D-7997-461D-9C93-F6237F17E25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1B362DE9-B935-4E7B-A707-993B5F98738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E8EC02C9-95A5-4D30-B56A-CBF45E6CF7B8}"/>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8" name="Footer Placeholder 7">
            <a:extLst>
              <a:ext uri="{FF2B5EF4-FFF2-40B4-BE49-F238E27FC236}">
                <a16:creationId xmlns:a16="http://schemas.microsoft.com/office/drawing/2014/main" xmlns="" id="{0AA31E0E-1BAC-4358-8F2F-75B4C993B22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F9995F2B-A9E4-4004-A0C1-6CBA9636E15B}"/>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979504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C043339-15CC-4A5E-8DC6-C5CA3DB5FBD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08977822-B094-4044-AEBF-61AF8F92C018}"/>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4" name="Footer Placeholder 3">
            <a:extLst>
              <a:ext uri="{FF2B5EF4-FFF2-40B4-BE49-F238E27FC236}">
                <a16:creationId xmlns:a16="http://schemas.microsoft.com/office/drawing/2014/main" xmlns="" id="{408EC187-3687-4F9B-B620-52621245D8A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C960564F-4639-43C3-B178-11E8C85FD969}"/>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5286728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7A739919-137C-459C-A6E4-208DD1CFBF80}"/>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3" name="Footer Placeholder 2">
            <a:extLst>
              <a:ext uri="{FF2B5EF4-FFF2-40B4-BE49-F238E27FC236}">
                <a16:creationId xmlns:a16="http://schemas.microsoft.com/office/drawing/2014/main" xmlns="" id="{192A3DFB-848C-4210-8294-FE5470ECA33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A5D4BAF2-69CC-4C2F-9482-CA1A7088C940}"/>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42183428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66B335F-3B6E-4D08-84B1-7A216BF3387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6AAD609E-E717-4C92-AC50-6E324D835A3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511CB1F5-0CA3-4E38-9E31-4960A75B9B4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FE84E147-E53F-48DB-86AD-34C049C66908}"/>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6" name="Footer Placeholder 5">
            <a:extLst>
              <a:ext uri="{FF2B5EF4-FFF2-40B4-BE49-F238E27FC236}">
                <a16:creationId xmlns:a16="http://schemas.microsoft.com/office/drawing/2014/main" xmlns="" id="{A2D4F9AE-2A9F-4D25-947D-21ED06B715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352C71E3-8208-4D51-9A65-DDB716F71740}"/>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34612834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0CAA330-99B7-40B6-A36C-002072328C5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390A55AB-0CAD-4450-B1CE-16B23771528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B1561BFA-B2A4-4DBF-B7B7-180C364FE4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12BF159C-4FBF-4C5D-B377-618E75736392}"/>
              </a:ext>
            </a:extLst>
          </p:cNvPr>
          <p:cNvSpPr>
            <a:spLocks noGrp="1"/>
          </p:cNvSpPr>
          <p:nvPr>
            <p:ph type="dt" sz="half" idx="10"/>
          </p:nvPr>
        </p:nvSpPr>
        <p:spPr/>
        <p:txBody>
          <a:bodyPr/>
          <a:lstStyle/>
          <a:p>
            <a:fld id="{E4EEFA04-0524-4627-93EC-A1636D7CEAEC}" type="datetimeFigureOut">
              <a:rPr lang="en-US" smtClean="0"/>
              <a:t>8/22/2021</a:t>
            </a:fld>
            <a:endParaRPr lang="en-US"/>
          </a:p>
        </p:txBody>
      </p:sp>
      <p:sp>
        <p:nvSpPr>
          <p:cNvPr id="6" name="Footer Placeholder 5">
            <a:extLst>
              <a:ext uri="{FF2B5EF4-FFF2-40B4-BE49-F238E27FC236}">
                <a16:creationId xmlns:a16="http://schemas.microsoft.com/office/drawing/2014/main" xmlns="" id="{238367D4-AC63-4305-BDC9-2333B19A217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7B001578-5F79-470B-B714-6D7D9386129B}"/>
              </a:ext>
            </a:extLst>
          </p:cNvPr>
          <p:cNvSpPr>
            <a:spLocks noGrp="1"/>
          </p:cNvSpPr>
          <p:nvPr>
            <p:ph type="sldNum" sz="quarter" idx="12"/>
          </p:nvPr>
        </p:nvSpPr>
        <p:spPr/>
        <p:txBody>
          <a:bodyPr/>
          <a:lstStyle/>
          <a:p>
            <a:fld id="{58578F79-59AF-457D-855A-C7D96116AA0B}" type="slidenum">
              <a:rPr lang="en-US" smtClean="0"/>
              <a:t>‹#›</a:t>
            </a:fld>
            <a:endParaRPr lang="en-US"/>
          </a:p>
        </p:txBody>
      </p:sp>
    </p:spTree>
    <p:extLst>
      <p:ext uri="{BB962C8B-B14F-4D97-AF65-F5344CB8AC3E}">
        <p14:creationId xmlns:p14="http://schemas.microsoft.com/office/powerpoint/2010/main" val="14135741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E13474D1-7D6E-4551-A4C1-5AB33AC012D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DF5706AE-B4C6-44E0-9F30-616F9587F9E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29ACA3A-34AE-47DE-9C6D-676497EC441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4EEFA04-0524-4627-93EC-A1636D7CEAEC}" type="datetimeFigureOut">
              <a:rPr lang="en-US" smtClean="0"/>
              <a:t>8/22/2021</a:t>
            </a:fld>
            <a:endParaRPr lang="en-US"/>
          </a:p>
        </p:txBody>
      </p:sp>
      <p:sp>
        <p:nvSpPr>
          <p:cNvPr id="5" name="Footer Placeholder 4">
            <a:extLst>
              <a:ext uri="{FF2B5EF4-FFF2-40B4-BE49-F238E27FC236}">
                <a16:creationId xmlns:a16="http://schemas.microsoft.com/office/drawing/2014/main" xmlns="" id="{193AC293-91E6-42DB-B1D0-E08C3067CA8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42E1CFAD-90AF-4DFA-8992-3924C5EF10D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8578F79-59AF-457D-855A-C7D96116AA0B}" type="slidenum">
              <a:rPr lang="en-US" smtClean="0"/>
              <a:t>‹#›</a:t>
            </a:fld>
            <a:endParaRPr lang="en-US"/>
          </a:p>
        </p:txBody>
      </p:sp>
    </p:spTree>
    <p:extLst>
      <p:ext uri="{BB962C8B-B14F-4D97-AF65-F5344CB8AC3E}">
        <p14:creationId xmlns:p14="http://schemas.microsoft.com/office/powerpoint/2010/main" val="26057251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xmlns="" id="{069B9411-EE85-4E74-B6FA-EEC8D582108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31093" y="86820"/>
            <a:ext cx="5528686" cy="5133780"/>
          </a:xfrm>
          <a:prstGeom prst="rect">
            <a:avLst/>
          </a:prstGeom>
        </p:spPr>
      </p:pic>
      <p:sp>
        <p:nvSpPr>
          <p:cNvPr id="2" name="TextBox 1">
            <a:extLst>
              <a:ext uri="{FF2B5EF4-FFF2-40B4-BE49-F238E27FC236}">
                <a16:creationId xmlns:a16="http://schemas.microsoft.com/office/drawing/2014/main" xmlns="" id="{DD2DD412-EE61-4DE8-96CF-5B0CCF2D31CD}"/>
              </a:ext>
            </a:extLst>
          </p:cNvPr>
          <p:cNvSpPr txBox="1"/>
          <p:nvPr/>
        </p:nvSpPr>
        <p:spPr>
          <a:xfrm>
            <a:off x="621437" y="5220599"/>
            <a:ext cx="11301273" cy="1477328"/>
          </a:xfrm>
          <a:prstGeom prst="rect">
            <a:avLst/>
          </a:prstGeom>
          <a:noFill/>
        </p:spPr>
        <p:txBody>
          <a:bodyPr wrap="square" rtlCol="0">
            <a:spAutoFit/>
          </a:bodyPr>
          <a:lstStyle/>
          <a:p>
            <a:pPr algn="just"/>
            <a:r>
              <a:rPr lang="en-US" b="1" dirty="0" smtClean="0">
                <a:latin typeface="Times New Roman" panose="02020603050405020304" pitchFamily="18" charset="0"/>
                <a:cs typeface="Times New Roman" panose="02020603050405020304" pitchFamily="18" charset="0"/>
              </a:rPr>
              <a:t>Figure </a:t>
            </a:r>
            <a:r>
              <a:rPr lang="en-US" b="1" dirty="0" err="1" smtClean="0">
                <a:latin typeface="Times New Roman" panose="02020603050405020304" pitchFamily="18" charset="0"/>
                <a:cs typeface="Times New Roman" panose="02020603050405020304" pitchFamily="18" charset="0"/>
              </a:rPr>
              <a:t>S1</a:t>
            </a:r>
            <a:r>
              <a:rPr lang="en-US" b="1" dirty="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GO analyses of DEGs between </a:t>
            </a:r>
            <a:r>
              <a:rPr lang="en-US" i="1" dirty="0">
                <a:latin typeface="Times New Roman" panose="02020603050405020304" pitchFamily="18" charset="0"/>
                <a:cs typeface="Times New Roman" panose="02020603050405020304" pitchFamily="18" charset="0"/>
              </a:rPr>
              <a:t>pl</a:t>
            </a:r>
            <a:r>
              <a:rPr lang="en-US" dirty="0">
                <a:latin typeface="Times New Roman" panose="02020603050405020304" pitchFamily="18" charset="0"/>
                <a:cs typeface="Times New Roman" panose="02020603050405020304" pitchFamily="18" charset="0"/>
              </a:rPr>
              <a:t> and WT by scattered diagram. Scattered plot represents the important enrichment functions. Here, horizontal axis represented the Rich Factor function (the number of differential genes annotated to the function divided by the number of genes annotated to the function) and the vertical axis represented information of functional annotation. The Q value size was represented by dot color, and the smaller the Q value was close to red. </a:t>
            </a:r>
          </a:p>
        </p:txBody>
      </p:sp>
    </p:spTree>
    <p:extLst>
      <p:ext uri="{BB962C8B-B14F-4D97-AF65-F5344CB8AC3E}">
        <p14:creationId xmlns:p14="http://schemas.microsoft.com/office/powerpoint/2010/main" val="1992202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a:srcRect l="17694" t="7728" r="7109"/>
          <a:stretch/>
        </p:blipFill>
        <p:spPr bwMode="auto">
          <a:xfrm>
            <a:off x="4896853" y="144379"/>
            <a:ext cx="5727031" cy="6713621"/>
          </a:xfrm>
          <a:prstGeom prst="rect">
            <a:avLst/>
          </a:prstGeom>
          <a:ln>
            <a:noFill/>
          </a:ln>
          <a:extLst>
            <a:ext uri="{53640926-AAD7-44D8-BBD7-CCE9431645EC}">
              <a14:shadowObscured xmlns:a14="http://schemas.microsoft.com/office/drawing/2010/main"/>
            </a:ext>
          </a:extLst>
        </p:spPr>
      </p:pic>
      <p:sp>
        <p:nvSpPr>
          <p:cNvPr id="3" name="TextBox 2"/>
          <p:cNvSpPr txBox="1"/>
          <p:nvPr/>
        </p:nvSpPr>
        <p:spPr>
          <a:xfrm>
            <a:off x="180474" y="6051884"/>
            <a:ext cx="3922294" cy="646331"/>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Figure </a:t>
            </a:r>
            <a:r>
              <a:rPr lang="en-US" b="1" dirty="0" err="1" smtClean="0">
                <a:latin typeface="Times New Roman" panose="02020603050405020304" pitchFamily="18" charset="0"/>
                <a:cs typeface="Times New Roman" panose="02020603050405020304" pitchFamily="18" charset="0"/>
              </a:rPr>
              <a:t>S2</a:t>
            </a:r>
            <a:r>
              <a:rPr lang="en-US" b="1" dirty="0" smtClean="0">
                <a:latin typeface="Times New Roman" panose="02020603050405020304" pitchFamily="18" charset="0"/>
                <a:cs typeface="Times New Roman" panose="02020603050405020304" pitchFamily="18" charset="0"/>
              </a:rPr>
              <a:t>: </a:t>
            </a:r>
            <a:r>
              <a:rPr lang="en-US" dirty="0" smtClean="0">
                <a:latin typeface="Times New Roman" panose="02020603050405020304" pitchFamily="18" charset="0"/>
                <a:cs typeface="Times New Roman" panose="02020603050405020304" pitchFamily="18" charset="0"/>
              </a:rPr>
              <a:t>Details pipeline of RNA-</a:t>
            </a:r>
            <a:r>
              <a:rPr lang="en-US" dirty="0" err="1" smtClean="0">
                <a:latin typeface="Times New Roman" panose="02020603050405020304" pitchFamily="18" charset="0"/>
                <a:cs typeface="Times New Roman" panose="02020603050405020304" pitchFamily="18" charset="0"/>
              </a:rPr>
              <a:t>seq</a:t>
            </a:r>
            <a:r>
              <a:rPr lang="en-US" dirty="0" smtClean="0">
                <a:latin typeface="Times New Roman" panose="02020603050405020304" pitchFamily="18" charset="0"/>
                <a:cs typeface="Times New Roman" panose="02020603050405020304" pitchFamily="18" charset="0"/>
              </a:rPr>
              <a:t> data analysis.</a:t>
            </a:r>
            <a:endParaRPr 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865349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TotalTime>
  <Words>94</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lara Akhter</dc:creator>
  <cp:lastModifiedBy>UKN</cp:lastModifiedBy>
  <cp:revision>6</cp:revision>
  <dcterms:created xsi:type="dcterms:W3CDTF">2020-12-28T13:03:47Z</dcterms:created>
  <dcterms:modified xsi:type="dcterms:W3CDTF">2021-08-22T02:43:13Z</dcterms:modified>
</cp:coreProperties>
</file>